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97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8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8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3263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hompson et al (2023) Diabetologia DOI 10.1007/s00125-023-05970-z </a:t>
            </a:r>
          </a:p>
          <a:p>
            <a:r>
              <a:rPr lang="en-GB" sz="1200" dirty="0"/>
              <a:t>©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Calibri" panose="020F0502020204030204" pitchFamily="34" charset="0"/>
              </a:rPr>
              <a:t>Human beta cell stress responses during the development of type 1 diabetes and effects on antigen presentation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DE4D862-3144-B21A-897F-1D6263E729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6103" y="1195881"/>
            <a:ext cx="6847818" cy="44662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ECD94A0-D489-1293-869D-40AA743B19D2}"/>
              </a:ext>
            </a:extLst>
          </p:cNvPr>
          <p:cNvSpPr txBox="1"/>
          <p:nvPr/>
        </p:nvSpPr>
        <p:spPr>
          <a:xfrm>
            <a:off x="253263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hompson et al (2023) Diabetologia DOI 10.1007/s00125-023-05970-z </a:t>
            </a:r>
          </a:p>
          <a:p>
            <a:r>
              <a:rPr lang="en-GB" sz="1200" dirty="0"/>
              <a:t>©The Authors 2023. Distributed under the terms of the CC BY 4.0 Attribution License (</a:t>
            </a:r>
            <a:r>
              <a:rPr lang="en-GB" sz="1200" dirty="0">
                <a:hlinkClick r:id="rId2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99E9FB1-9EF2-8D19-E969-579F7F8E9B35}"/>
              </a:ext>
            </a:extLst>
          </p:cNvPr>
          <p:cNvSpPr txBox="1"/>
          <p:nvPr/>
        </p:nvSpPr>
        <p:spPr>
          <a:xfrm>
            <a:off x="323528" y="260648"/>
            <a:ext cx="8587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Calibri" panose="020F0502020204030204" pitchFamily="34" charset="0"/>
              </a:rPr>
              <a:t>Heterogeneity in the autoimmune response in type 1 diabetes and its potential relationship with inter-individual heterogeneity in residual beta cell mass</a:t>
            </a:r>
            <a:endParaRPr lang="en-GB" sz="2000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B1427F96-A6F3-4E80-8337-C630E2543D8F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00CE9D4-A610-60C6-2860-D8F495EBFF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6123" y="1153992"/>
            <a:ext cx="4151753" cy="4550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4396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119</Words>
  <Application>Microsoft Office PowerPoint</Application>
  <PresentationFormat>On-screen Show (4:3)</PresentationFormat>
  <Paragraphs>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4</cp:revision>
  <dcterms:created xsi:type="dcterms:W3CDTF">2016-06-15T12:53:43Z</dcterms:created>
  <dcterms:modified xsi:type="dcterms:W3CDTF">2023-07-18T11:55:55Z</dcterms:modified>
</cp:coreProperties>
</file>